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media/image9.png" ContentType="image/png"/>
  <Override PartName="/ppt/media/image8.wmf" ContentType="image/x-wmf"/>
  <Override PartName="/ppt/media/image13.png" ContentType="image/png"/>
  <Override PartName="/ppt/media/image7.wmf" ContentType="image/x-wmf"/>
  <Override PartName="/ppt/media/image12.png" ContentType="image/png"/>
  <Override PartName="/ppt/media/image6.wmf" ContentType="image/x-wmf"/>
  <Override PartName="/ppt/media/image11.png" ContentType="image/png"/>
  <Override PartName="/ppt/media/image5.wmf" ContentType="image/x-wmf"/>
  <Override PartName="/ppt/media/image10.png" ContentType="image/png"/>
  <Override PartName="/ppt/media/image4.wmf" ContentType="image/x-wmf"/>
  <Override PartName="/ppt/media/image3.wmf" ContentType="image/x-wmf"/>
  <Override PartName="/ppt/media/image24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.wmf" ContentType="image/x-wmf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4223BC-A24D-4D97-B5F2-E20FBC7ED0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7018EE-B6DF-4CC6-A988-661A7F4953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07FFF-0AA2-462B-A0AE-B507D478B7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7005E8-BA93-4DC5-A024-873987935A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D0D6D8-46A1-42D8-9AA9-0B474F43BE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041417-D8A2-4CF9-922C-98CA1D728B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B9F31A-365C-4C18-AFAB-2D7FFB4B93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4DFBE3-1FD5-4822-BB7A-73E5B6882A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202BD5-11AC-43FB-B298-B58C3CB706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4B625-0637-4B5A-9812-8BB931ED91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0D0AD9-49F7-4374-B880-1E5E1B5FF8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A3B9C-4402-416B-8FE1-6CD4F753A7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87D475-3B87-40A4-94C5-864A6B97854B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4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5.wmf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6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7.wmf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8.wmf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5" Type="http://schemas.openxmlformats.org/officeDocument/2006/relationships/image" Target="../media/image13.png"/><Relationship Id="rId6" Type="http://schemas.openxmlformats.org/officeDocument/2006/relationships/image" Target="../media/image14.pn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298600" y="2514600"/>
            <a:ext cx="1511280" cy="990720"/>
            <a:chOff x="2298600" y="2514600"/>
            <a:chExt cx="1511280" cy="990720"/>
          </a:xfrm>
        </p:grpSpPr>
        <p:grpSp>
          <p:nvGrpSpPr>
            <p:cNvPr id="42" name=""/>
            <p:cNvGrpSpPr/>
            <p:nvPr/>
          </p:nvGrpSpPr>
          <p:grpSpPr>
            <a:xfrm>
              <a:off x="2362320" y="2519280"/>
              <a:ext cx="1447560" cy="986040"/>
              <a:chOff x="2362320" y="2519280"/>
              <a:chExt cx="1447560" cy="986040"/>
            </a:xfrm>
          </p:grpSpPr>
          <p:graphicFrame>
            <p:nvGraphicFramePr>
              <p:cNvPr id="43" name=""/>
              <p:cNvGraphicFramePr/>
              <p:nvPr/>
            </p:nvGraphicFramePr>
            <p:xfrm>
              <a:off x="2435400" y="2519280"/>
              <a:ext cx="1295280" cy="986040"/>
            </p:xfrm>
            <a:graphic>
              <a:graphicData uri="http://schemas.openxmlformats.org/presentationml/2006/ole">
                <p:oleObj progId="Excel.Sheet.12" r:id="rId1" spid="">
                  <p:embed/>
                  <p:pic>
                    <p:nvPicPr>
                      <p:cNvPr id="44" name="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2435400" y="2519280"/>
                        <a:ext cx="1295280" cy="9860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45" name=""/>
              <p:cNvSpPr/>
              <p:nvPr/>
            </p:nvSpPr>
            <p:spPr>
              <a:xfrm>
                <a:off x="2362320" y="3425760"/>
                <a:ext cx="1447560" cy="76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520" bIns="295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46" name=""/>
            <p:cNvSpPr/>
            <p:nvPr/>
          </p:nvSpPr>
          <p:spPr>
            <a:xfrm>
              <a:off x="2298600" y="2514600"/>
              <a:ext cx="228600" cy="914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47" name=""/>
          <p:cNvGrpSpPr/>
          <p:nvPr/>
        </p:nvGrpSpPr>
        <p:grpSpPr>
          <a:xfrm>
            <a:off x="3838680" y="2438280"/>
            <a:ext cx="1393200" cy="1066680"/>
            <a:chOff x="3838680" y="2438280"/>
            <a:chExt cx="1393200" cy="1066680"/>
          </a:xfrm>
        </p:grpSpPr>
        <p:grpSp>
          <p:nvGrpSpPr>
            <p:cNvPr id="48" name=""/>
            <p:cNvGrpSpPr/>
            <p:nvPr/>
          </p:nvGrpSpPr>
          <p:grpSpPr>
            <a:xfrm>
              <a:off x="3860640" y="2519280"/>
              <a:ext cx="1371240" cy="985680"/>
              <a:chOff x="3860640" y="2519280"/>
              <a:chExt cx="1371240" cy="985680"/>
            </a:xfrm>
          </p:grpSpPr>
          <p:graphicFrame>
            <p:nvGraphicFramePr>
              <p:cNvPr id="49" name=""/>
              <p:cNvGraphicFramePr/>
              <p:nvPr/>
            </p:nvGraphicFramePr>
            <p:xfrm>
              <a:off x="3901320" y="2519280"/>
              <a:ext cx="1295280" cy="985680"/>
            </p:xfrm>
            <a:graphic>
              <a:graphicData uri="http://schemas.openxmlformats.org/presentationml/2006/ole">
                <p:oleObj progId="Excel.Sheet.12" r:id="rId3" spid="">
                  <p:embed/>
                  <p:pic>
                    <p:nvPicPr>
                      <p:cNvPr id="50" name="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3901320" y="2519280"/>
                        <a:ext cx="1295280" cy="9856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51" name=""/>
              <p:cNvSpPr/>
              <p:nvPr/>
            </p:nvSpPr>
            <p:spPr>
              <a:xfrm>
                <a:off x="3860640" y="3429000"/>
                <a:ext cx="1371240" cy="759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160" bIns="291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52" name=""/>
            <p:cNvSpPr/>
            <p:nvPr/>
          </p:nvSpPr>
          <p:spPr>
            <a:xfrm>
              <a:off x="3838680" y="2438280"/>
              <a:ext cx="151920" cy="1066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53" name=""/>
          <p:cNvGrpSpPr/>
          <p:nvPr/>
        </p:nvGrpSpPr>
        <p:grpSpPr>
          <a:xfrm>
            <a:off x="5410080" y="2438280"/>
            <a:ext cx="1371600" cy="1067040"/>
            <a:chOff x="5410080" y="2438280"/>
            <a:chExt cx="1371600" cy="1067040"/>
          </a:xfrm>
        </p:grpSpPr>
        <p:grpSp>
          <p:nvGrpSpPr>
            <p:cNvPr id="54" name=""/>
            <p:cNvGrpSpPr/>
            <p:nvPr/>
          </p:nvGrpSpPr>
          <p:grpSpPr>
            <a:xfrm>
              <a:off x="5410080" y="2514600"/>
              <a:ext cx="1371600" cy="985680"/>
              <a:chOff x="5410080" y="2514600"/>
              <a:chExt cx="1371600" cy="985680"/>
            </a:xfrm>
          </p:grpSpPr>
          <p:graphicFrame>
            <p:nvGraphicFramePr>
              <p:cNvPr id="55" name=""/>
              <p:cNvGraphicFramePr/>
              <p:nvPr/>
            </p:nvGraphicFramePr>
            <p:xfrm>
              <a:off x="5410080" y="2514600"/>
              <a:ext cx="1295640" cy="985680"/>
            </p:xfrm>
            <a:graphic>
              <a:graphicData uri="http://schemas.openxmlformats.org/presentationml/2006/ole">
                <p:oleObj progId="Excel.Sheet.12" r:id="rId5" spid="">
                  <p:embed/>
                  <p:pic>
                    <p:nvPicPr>
                      <p:cNvPr id="56" name="" descr=""/>
                      <p:cNvPicPr/>
                      <p:nvPr/>
                    </p:nvPicPr>
                    <p:blipFill>
                      <a:blip r:embed="rId6"/>
                      <a:stretch/>
                    </p:blipFill>
                    <p:spPr>
                      <a:xfrm>
                        <a:off x="5410080" y="2514600"/>
                        <a:ext cx="1295640" cy="9856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57" name=""/>
              <p:cNvSpPr/>
              <p:nvPr/>
            </p:nvSpPr>
            <p:spPr>
              <a:xfrm>
                <a:off x="5410080" y="3419640"/>
                <a:ext cx="1371600" cy="759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160" bIns="291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58" name=""/>
            <p:cNvSpPr/>
            <p:nvPr/>
          </p:nvSpPr>
          <p:spPr>
            <a:xfrm>
              <a:off x="5429160" y="2438280"/>
              <a:ext cx="76320" cy="1067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59" name=""/>
          <p:cNvGrpSpPr/>
          <p:nvPr/>
        </p:nvGrpSpPr>
        <p:grpSpPr>
          <a:xfrm>
            <a:off x="6072480" y="3387600"/>
            <a:ext cx="409320" cy="200520"/>
            <a:chOff x="6072480" y="3387600"/>
            <a:chExt cx="409320" cy="200520"/>
          </a:xfrm>
        </p:grpSpPr>
        <p:sp>
          <p:nvSpPr>
            <p:cNvPr id="60" name=""/>
            <p:cNvSpPr/>
            <p:nvPr/>
          </p:nvSpPr>
          <p:spPr>
            <a:xfrm>
              <a:off x="6072480" y="338760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6133320" y="338760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203880" y="338760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146640" y="354024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4" name=""/>
          <p:cNvSpPr/>
          <p:nvPr/>
        </p:nvSpPr>
        <p:spPr>
          <a:xfrm>
            <a:off x="5519880" y="352440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5767560" y="352440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6132600" y="352440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6396120" y="352440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5564880" y="369396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53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6198120" y="369396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67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5784840" y="255600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6072120" y="255600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6410160" y="255600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6124680" y="255600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4" name=""/>
          <p:cNvGrpSpPr/>
          <p:nvPr/>
        </p:nvGrpSpPr>
        <p:grpSpPr>
          <a:xfrm>
            <a:off x="6343920" y="3386160"/>
            <a:ext cx="409320" cy="200520"/>
            <a:chOff x="6343920" y="3386160"/>
            <a:chExt cx="409320" cy="200520"/>
          </a:xfrm>
        </p:grpSpPr>
        <p:sp>
          <p:nvSpPr>
            <p:cNvPr id="75" name=""/>
            <p:cNvSpPr/>
            <p:nvPr/>
          </p:nvSpPr>
          <p:spPr>
            <a:xfrm>
              <a:off x="6343920" y="338616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404760" y="338616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6475320" y="338616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418080" y="353844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79" name=""/>
          <p:cNvGrpSpPr/>
          <p:nvPr/>
        </p:nvGrpSpPr>
        <p:grpSpPr>
          <a:xfrm>
            <a:off x="5437440" y="3386160"/>
            <a:ext cx="409320" cy="200520"/>
            <a:chOff x="5437440" y="3386160"/>
            <a:chExt cx="409320" cy="200520"/>
          </a:xfrm>
        </p:grpSpPr>
        <p:sp>
          <p:nvSpPr>
            <p:cNvPr id="80" name=""/>
            <p:cNvSpPr/>
            <p:nvPr/>
          </p:nvSpPr>
          <p:spPr>
            <a:xfrm>
              <a:off x="5437440" y="338616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498280" y="338616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568840" y="338616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511600" y="353844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84" name=""/>
          <p:cNvGrpSpPr/>
          <p:nvPr/>
        </p:nvGrpSpPr>
        <p:grpSpPr>
          <a:xfrm>
            <a:off x="5720040" y="3387600"/>
            <a:ext cx="409320" cy="200520"/>
            <a:chOff x="5720040" y="3387600"/>
            <a:chExt cx="409320" cy="200520"/>
          </a:xfrm>
        </p:grpSpPr>
        <p:sp>
          <p:nvSpPr>
            <p:cNvPr id="85" name=""/>
            <p:cNvSpPr/>
            <p:nvPr/>
          </p:nvSpPr>
          <p:spPr>
            <a:xfrm>
              <a:off x="5720040" y="338760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780880" y="338760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5851440" y="338760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794200" y="354024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9" name=""/>
          <p:cNvSpPr/>
          <p:nvPr/>
        </p:nvSpPr>
        <p:spPr>
          <a:xfrm rot="16200000">
            <a:off x="1638720" y="2856960"/>
            <a:ext cx="117432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rmalized transcript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bundanc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0" name=""/>
          <p:cNvGrpSpPr/>
          <p:nvPr/>
        </p:nvGrpSpPr>
        <p:grpSpPr>
          <a:xfrm>
            <a:off x="3094200" y="3397320"/>
            <a:ext cx="409320" cy="200520"/>
            <a:chOff x="3094200" y="3397320"/>
            <a:chExt cx="409320" cy="200520"/>
          </a:xfrm>
        </p:grpSpPr>
        <p:sp>
          <p:nvSpPr>
            <p:cNvPr id="91" name=""/>
            <p:cNvSpPr/>
            <p:nvPr/>
          </p:nvSpPr>
          <p:spPr>
            <a:xfrm>
              <a:off x="3094200" y="339732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155040" y="339732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225600" y="339732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168360" y="354960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5" name=""/>
          <p:cNvSpPr/>
          <p:nvPr/>
        </p:nvSpPr>
        <p:spPr>
          <a:xfrm>
            <a:off x="2541960" y="35337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2789640" y="35337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3154680" y="35337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3418200" y="35337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2586600" y="370368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53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3219840" y="370368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67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2806560" y="256536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3094200" y="256536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3432240" y="256536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3146400" y="256536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05" name=""/>
          <p:cNvGrpSpPr/>
          <p:nvPr/>
        </p:nvGrpSpPr>
        <p:grpSpPr>
          <a:xfrm>
            <a:off x="3372120" y="3397320"/>
            <a:ext cx="409320" cy="200520"/>
            <a:chOff x="3372120" y="3397320"/>
            <a:chExt cx="409320" cy="200520"/>
          </a:xfrm>
        </p:grpSpPr>
        <p:sp>
          <p:nvSpPr>
            <p:cNvPr id="106" name=""/>
            <p:cNvSpPr/>
            <p:nvPr/>
          </p:nvSpPr>
          <p:spPr>
            <a:xfrm>
              <a:off x="3372120" y="339732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432960" y="339732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503520" y="339732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3446280" y="354960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10" name=""/>
          <p:cNvGrpSpPr/>
          <p:nvPr/>
        </p:nvGrpSpPr>
        <p:grpSpPr>
          <a:xfrm>
            <a:off x="2459160" y="3395520"/>
            <a:ext cx="409320" cy="200520"/>
            <a:chOff x="2459160" y="3395520"/>
            <a:chExt cx="409320" cy="200520"/>
          </a:xfrm>
        </p:grpSpPr>
        <p:sp>
          <p:nvSpPr>
            <p:cNvPr id="111" name=""/>
            <p:cNvSpPr/>
            <p:nvPr/>
          </p:nvSpPr>
          <p:spPr>
            <a:xfrm>
              <a:off x="2459160" y="339552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520000" y="339552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2590560" y="339552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533320" y="354816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15" name=""/>
          <p:cNvGrpSpPr/>
          <p:nvPr/>
        </p:nvGrpSpPr>
        <p:grpSpPr>
          <a:xfrm>
            <a:off x="2741760" y="3397320"/>
            <a:ext cx="409320" cy="200520"/>
            <a:chOff x="2741760" y="3397320"/>
            <a:chExt cx="409320" cy="200520"/>
          </a:xfrm>
        </p:grpSpPr>
        <p:sp>
          <p:nvSpPr>
            <p:cNvPr id="116" name=""/>
            <p:cNvSpPr/>
            <p:nvPr/>
          </p:nvSpPr>
          <p:spPr>
            <a:xfrm>
              <a:off x="2741760" y="339732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802600" y="339732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2873160" y="339732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815920" y="354960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20" name=""/>
          <p:cNvGrpSpPr/>
          <p:nvPr/>
        </p:nvGrpSpPr>
        <p:grpSpPr>
          <a:xfrm>
            <a:off x="4567320" y="3397320"/>
            <a:ext cx="409320" cy="200520"/>
            <a:chOff x="4567320" y="3397320"/>
            <a:chExt cx="409320" cy="200520"/>
          </a:xfrm>
        </p:grpSpPr>
        <p:sp>
          <p:nvSpPr>
            <p:cNvPr id="121" name=""/>
            <p:cNvSpPr/>
            <p:nvPr/>
          </p:nvSpPr>
          <p:spPr>
            <a:xfrm>
              <a:off x="4567320" y="339732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628160" y="339732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698720" y="339732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641480" y="354960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25" name=""/>
          <p:cNvSpPr/>
          <p:nvPr/>
        </p:nvSpPr>
        <p:spPr>
          <a:xfrm>
            <a:off x="4015080" y="35337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4262760" y="35337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4627800" y="35337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4891320" y="35337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4059720" y="370368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53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4693320" y="370368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67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4280040" y="256536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4567320" y="256536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4905360" y="256536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4619520" y="256536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35" name=""/>
          <p:cNvGrpSpPr/>
          <p:nvPr/>
        </p:nvGrpSpPr>
        <p:grpSpPr>
          <a:xfrm>
            <a:off x="4845240" y="3395520"/>
            <a:ext cx="409320" cy="200520"/>
            <a:chOff x="4845240" y="3395520"/>
            <a:chExt cx="409320" cy="200520"/>
          </a:xfrm>
        </p:grpSpPr>
        <p:sp>
          <p:nvSpPr>
            <p:cNvPr id="136" name=""/>
            <p:cNvSpPr/>
            <p:nvPr/>
          </p:nvSpPr>
          <p:spPr>
            <a:xfrm>
              <a:off x="4845240" y="339552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906080" y="339552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4976640" y="339552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4919400" y="354816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40" name=""/>
          <p:cNvGrpSpPr/>
          <p:nvPr/>
        </p:nvGrpSpPr>
        <p:grpSpPr>
          <a:xfrm>
            <a:off x="3930840" y="3395520"/>
            <a:ext cx="409320" cy="200520"/>
            <a:chOff x="3930840" y="3395520"/>
            <a:chExt cx="409320" cy="200520"/>
          </a:xfrm>
        </p:grpSpPr>
        <p:sp>
          <p:nvSpPr>
            <p:cNvPr id="141" name=""/>
            <p:cNvSpPr/>
            <p:nvPr/>
          </p:nvSpPr>
          <p:spPr>
            <a:xfrm>
              <a:off x="3930840" y="339552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991680" y="339552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4062240" y="339552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4005000" y="354816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45" name=""/>
          <p:cNvGrpSpPr/>
          <p:nvPr/>
        </p:nvGrpSpPr>
        <p:grpSpPr>
          <a:xfrm>
            <a:off x="4214880" y="3397320"/>
            <a:ext cx="409320" cy="200520"/>
            <a:chOff x="4214880" y="3397320"/>
            <a:chExt cx="409320" cy="200520"/>
          </a:xfrm>
        </p:grpSpPr>
        <p:sp>
          <p:nvSpPr>
            <p:cNvPr id="146" name=""/>
            <p:cNvSpPr/>
            <p:nvPr/>
          </p:nvSpPr>
          <p:spPr>
            <a:xfrm>
              <a:off x="4214880" y="339732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4275720" y="339732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4346280" y="339732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4289040" y="354960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50" name=""/>
          <p:cNvSpPr/>
          <p:nvPr/>
        </p:nvSpPr>
        <p:spPr>
          <a:xfrm>
            <a:off x="5520240" y="2270160"/>
            <a:ext cx="110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O7463 cvn1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4038840" y="2270160"/>
            <a:ext cx="110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O7422 cvn1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2591280" y="2270160"/>
            <a:ext cx="1038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O5544 cvn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-8640" y="4693680"/>
            <a:ext cx="91587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ig. S1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qRT-PCR analysis confirms that transcription of the first gene in each of cvns 1, 10 and 13 is repressed following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induction of ppGpp synthesis in M653 [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relA tipAp::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(1.46kb)] but unaffected in the control strain M667 [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relA tipAp::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]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In each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iological replicate experiment, R1-R2, lane 1corresponds to the pre-induction sample (0 min) and lanes 2 and 3 correspond to the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amples taken 60 min after induction or non-induction with thiostrepton, respectively. The average of three qRT-PCR determinations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s shown, and standard deviations are marked with error bar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4" name=""/>
          <p:cNvGrpSpPr/>
          <p:nvPr/>
        </p:nvGrpSpPr>
        <p:grpSpPr>
          <a:xfrm>
            <a:off x="3838680" y="1676520"/>
            <a:ext cx="1423440" cy="1066680"/>
            <a:chOff x="3838680" y="1676520"/>
            <a:chExt cx="1423440" cy="1066680"/>
          </a:xfrm>
        </p:grpSpPr>
        <p:graphicFrame>
          <p:nvGraphicFramePr>
            <p:cNvPr id="155" name=""/>
            <p:cNvGraphicFramePr/>
            <p:nvPr/>
          </p:nvGraphicFramePr>
          <p:xfrm>
            <a:off x="3838680" y="1752480"/>
            <a:ext cx="1294920" cy="98604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156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838680" y="1752480"/>
                      <a:ext cx="1294920" cy="986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57" name=""/>
            <p:cNvSpPr/>
            <p:nvPr/>
          </p:nvSpPr>
          <p:spPr>
            <a:xfrm>
              <a:off x="3852720" y="1676520"/>
              <a:ext cx="75600" cy="1066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3890880" y="2662200"/>
              <a:ext cx="1371240" cy="76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520" bIns="2952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59" name=""/>
          <p:cNvGrpSpPr/>
          <p:nvPr/>
        </p:nvGrpSpPr>
        <p:grpSpPr>
          <a:xfrm>
            <a:off x="3833640" y="2819520"/>
            <a:ext cx="1371600" cy="1066680"/>
            <a:chOff x="3833640" y="2819520"/>
            <a:chExt cx="1371600" cy="1066680"/>
          </a:xfrm>
        </p:grpSpPr>
        <p:graphicFrame>
          <p:nvGraphicFramePr>
            <p:cNvPr id="160" name=""/>
            <p:cNvGraphicFramePr/>
            <p:nvPr/>
          </p:nvGraphicFramePr>
          <p:xfrm>
            <a:off x="3833640" y="2871720"/>
            <a:ext cx="1295640" cy="98604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161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833640" y="2871720"/>
                      <a:ext cx="1295640" cy="986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62" name=""/>
            <p:cNvSpPr/>
            <p:nvPr/>
          </p:nvSpPr>
          <p:spPr>
            <a:xfrm>
              <a:off x="3833640" y="3776760"/>
              <a:ext cx="1371600" cy="75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3857400" y="2819520"/>
              <a:ext cx="76320" cy="1066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64" name=""/>
          <p:cNvSpPr/>
          <p:nvPr/>
        </p:nvSpPr>
        <p:spPr>
          <a:xfrm>
            <a:off x="3841920" y="2660760"/>
            <a:ext cx="1506240" cy="104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3822840" y="1774800"/>
            <a:ext cx="106200" cy="1044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 rot="16200000">
            <a:off x="2850480" y="2784240"/>
            <a:ext cx="167724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rmalized transcript abundanc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67" name=""/>
          <p:cNvGrpSpPr/>
          <p:nvPr/>
        </p:nvGrpSpPr>
        <p:grpSpPr>
          <a:xfrm>
            <a:off x="3862800" y="3733920"/>
            <a:ext cx="375120" cy="200520"/>
            <a:chOff x="3862800" y="3733920"/>
            <a:chExt cx="375120" cy="200520"/>
          </a:xfrm>
        </p:grpSpPr>
        <p:grpSp>
          <p:nvGrpSpPr>
            <p:cNvPr id="168" name=""/>
            <p:cNvGrpSpPr/>
            <p:nvPr/>
          </p:nvGrpSpPr>
          <p:grpSpPr>
            <a:xfrm>
              <a:off x="3862800" y="3733920"/>
              <a:ext cx="375120" cy="200520"/>
              <a:chOff x="3862800" y="3733920"/>
              <a:chExt cx="375120" cy="200520"/>
            </a:xfrm>
          </p:grpSpPr>
          <p:sp>
            <p:nvSpPr>
              <p:cNvPr id="169" name=""/>
              <p:cNvSpPr/>
              <p:nvPr/>
            </p:nvSpPr>
            <p:spPr>
              <a:xfrm>
                <a:off x="3862800" y="37339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170" name=""/>
              <p:cNvGrpSpPr/>
              <p:nvPr/>
            </p:nvGrpSpPr>
            <p:grpSpPr>
              <a:xfrm>
                <a:off x="3932640" y="3733920"/>
                <a:ext cx="305280" cy="200520"/>
                <a:chOff x="3932640" y="3733920"/>
                <a:chExt cx="305280" cy="200520"/>
              </a:xfrm>
            </p:grpSpPr>
            <p:sp>
              <p:nvSpPr>
                <p:cNvPr id="171" name=""/>
                <p:cNvSpPr/>
                <p:nvPr/>
              </p:nvSpPr>
              <p:spPr>
                <a:xfrm>
                  <a:off x="393264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72" name=""/>
                <p:cNvSpPr/>
                <p:nvPr/>
              </p:nvSpPr>
              <p:spPr>
                <a:xfrm>
                  <a:off x="400860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173" name=""/>
            <p:cNvSpPr/>
            <p:nvPr/>
          </p:nvSpPr>
          <p:spPr>
            <a:xfrm>
              <a:off x="3962520" y="3886200"/>
              <a:ext cx="17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74" name=""/>
          <p:cNvGrpSpPr/>
          <p:nvPr/>
        </p:nvGrpSpPr>
        <p:grpSpPr>
          <a:xfrm>
            <a:off x="4083480" y="3733920"/>
            <a:ext cx="375120" cy="200520"/>
            <a:chOff x="4083480" y="3733920"/>
            <a:chExt cx="375120" cy="200520"/>
          </a:xfrm>
        </p:grpSpPr>
        <p:grpSp>
          <p:nvGrpSpPr>
            <p:cNvPr id="175" name=""/>
            <p:cNvGrpSpPr/>
            <p:nvPr/>
          </p:nvGrpSpPr>
          <p:grpSpPr>
            <a:xfrm>
              <a:off x="4083480" y="3733920"/>
              <a:ext cx="375120" cy="200520"/>
              <a:chOff x="4083480" y="3733920"/>
              <a:chExt cx="375120" cy="200520"/>
            </a:xfrm>
          </p:grpSpPr>
          <p:sp>
            <p:nvSpPr>
              <p:cNvPr id="176" name=""/>
              <p:cNvSpPr/>
              <p:nvPr/>
            </p:nvSpPr>
            <p:spPr>
              <a:xfrm>
                <a:off x="4083480" y="37339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177" name=""/>
              <p:cNvGrpSpPr/>
              <p:nvPr/>
            </p:nvGrpSpPr>
            <p:grpSpPr>
              <a:xfrm>
                <a:off x="4153320" y="3733920"/>
                <a:ext cx="305280" cy="200520"/>
                <a:chOff x="4153320" y="3733920"/>
                <a:chExt cx="305280" cy="200520"/>
              </a:xfrm>
            </p:grpSpPr>
            <p:sp>
              <p:nvSpPr>
                <p:cNvPr id="178" name=""/>
                <p:cNvSpPr/>
                <p:nvPr/>
              </p:nvSpPr>
              <p:spPr>
                <a:xfrm>
                  <a:off x="415332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79" name=""/>
                <p:cNvSpPr/>
                <p:nvPr/>
              </p:nvSpPr>
              <p:spPr>
                <a:xfrm>
                  <a:off x="422928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180" name=""/>
            <p:cNvSpPr/>
            <p:nvPr/>
          </p:nvSpPr>
          <p:spPr>
            <a:xfrm>
              <a:off x="4183200" y="3886200"/>
              <a:ext cx="17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81" name=""/>
          <p:cNvGrpSpPr/>
          <p:nvPr/>
        </p:nvGrpSpPr>
        <p:grpSpPr>
          <a:xfrm>
            <a:off x="4307400" y="3733920"/>
            <a:ext cx="375120" cy="200520"/>
            <a:chOff x="4307400" y="3733920"/>
            <a:chExt cx="375120" cy="200520"/>
          </a:xfrm>
        </p:grpSpPr>
        <p:grpSp>
          <p:nvGrpSpPr>
            <p:cNvPr id="182" name=""/>
            <p:cNvGrpSpPr/>
            <p:nvPr/>
          </p:nvGrpSpPr>
          <p:grpSpPr>
            <a:xfrm>
              <a:off x="4307400" y="3733920"/>
              <a:ext cx="375120" cy="200520"/>
              <a:chOff x="4307400" y="3733920"/>
              <a:chExt cx="375120" cy="200520"/>
            </a:xfrm>
          </p:grpSpPr>
          <p:sp>
            <p:nvSpPr>
              <p:cNvPr id="183" name=""/>
              <p:cNvSpPr/>
              <p:nvPr/>
            </p:nvSpPr>
            <p:spPr>
              <a:xfrm>
                <a:off x="4307400" y="37339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184" name=""/>
              <p:cNvGrpSpPr/>
              <p:nvPr/>
            </p:nvGrpSpPr>
            <p:grpSpPr>
              <a:xfrm>
                <a:off x="4377240" y="3733920"/>
                <a:ext cx="305280" cy="200520"/>
                <a:chOff x="4377240" y="3733920"/>
                <a:chExt cx="305280" cy="200520"/>
              </a:xfrm>
            </p:grpSpPr>
            <p:sp>
              <p:nvSpPr>
                <p:cNvPr id="185" name=""/>
                <p:cNvSpPr/>
                <p:nvPr/>
              </p:nvSpPr>
              <p:spPr>
                <a:xfrm>
                  <a:off x="437724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86" name=""/>
                <p:cNvSpPr/>
                <p:nvPr/>
              </p:nvSpPr>
              <p:spPr>
                <a:xfrm>
                  <a:off x="445320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187" name=""/>
            <p:cNvSpPr/>
            <p:nvPr/>
          </p:nvSpPr>
          <p:spPr>
            <a:xfrm>
              <a:off x="4407120" y="3886200"/>
              <a:ext cx="17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88" name=""/>
          <p:cNvGrpSpPr/>
          <p:nvPr/>
        </p:nvGrpSpPr>
        <p:grpSpPr>
          <a:xfrm>
            <a:off x="4599360" y="3733920"/>
            <a:ext cx="374760" cy="200520"/>
            <a:chOff x="4599360" y="3733920"/>
            <a:chExt cx="374760" cy="200520"/>
          </a:xfrm>
        </p:grpSpPr>
        <p:grpSp>
          <p:nvGrpSpPr>
            <p:cNvPr id="189" name=""/>
            <p:cNvGrpSpPr/>
            <p:nvPr/>
          </p:nvGrpSpPr>
          <p:grpSpPr>
            <a:xfrm>
              <a:off x="4599360" y="3733920"/>
              <a:ext cx="374760" cy="200520"/>
              <a:chOff x="4599360" y="3733920"/>
              <a:chExt cx="374760" cy="200520"/>
            </a:xfrm>
          </p:grpSpPr>
          <p:sp>
            <p:nvSpPr>
              <p:cNvPr id="190" name=""/>
              <p:cNvSpPr/>
              <p:nvPr/>
            </p:nvSpPr>
            <p:spPr>
              <a:xfrm>
                <a:off x="4599360" y="37339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191" name=""/>
              <p:cNvGrpSpPr/>
              <p:nvPr/>
            </p:nvGrpSpPr>
            <p:grpSpPr>
              <a:xfrm>
                <a:off x="4668840" y="3733920"/>
                <a:ext cx="305280" cy="200520"/>
                <a:chOff x="4668840" y="3733920"/>
                <a:chExt cx="305280" cy="200520"/>
              </a:xfrm>
            </p:grpSpPr>
            <p:sp>
              <p:nvSpPr>
                <p:cNvPr id="192" name=""/>
                <p:cNvSpPr/>
                <p:nvPr/>
              </p:nvSpPr>
              <p:spPr>
                <a:xfrm>
                  <a:off x="466884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93" name=""/>
                <p:cNvSpPr/>
                <p:nvPr/>
              </p:nvSpPr>
              <p:spPr>
                <a:xfrm>
                  <a:off x="474480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194" name=""/>
            <p:cNvSpPr/>
            <p:nvPr/>
          </p:nvSpPr>
          <p:spPr>
            <a:xfrm>
              <a:off x="4699080" y="3886200"/>
              <a:ext cx="178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95" name=""/>
          <p:cNvGrpSpPr/>
          <p:nvPr/>
        </p:nvGrpSpPr>
        <p:grpSpPr>
          <a:xfrm>
            <a:off x="4820040" y="3733920"/>
            <a:ext cx="374760" cy="200520"/>
            <a:chOff x="4820040" y="3733920"/>
            <a:chExt cx="374760" cy="200520"/>
          </a:xfrm>
        </p:grpSpPr>
        <p:grpSp>
          <p:nvGrpSpPr>
            <p:cNvPr id="196" name=""/>
            <p:cNvGrpSpPr/>
            <p:nvPr/>
          </p:nvGrpSpPr>
          <p:grpSpPr>
            <a:xfrm>
              <a:off x="4820040" y="3733920"/>
              <a:ext cx="374760" cy="200520"/>
              <a:chOff x="4820040" y="3733920"/>
              <a:chExt cx="374760" cy="200520"/>
            </a:xfrm>
          </p:grpSpPr>
          <p:sp>
            <p:nvSpPr>
              <p:cNvPr id="197" name=""/>
              <p:cNvSpPr/>
              <p:nvPr/>
            </p:nvSpPr>
            <p:spPr>
              <a:xfrm>
                <a:off x="4820040" y="37339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198" name=""/>
              <p:cNvGrpSpPr/>
              <p:nvPr/>
            </p:nvGrpSpPr>
            <p:grpSpPr>
              <a:xfrm>
                <a:off x="4889520" y="3733920"/>
                <a:ext cx="305280" cy="200520"/>
                <a:chOff x="4889520" y="3733920"/>
                <a:chExt cx="305280" cy="200520"/>
              </a:xfrm>
            </p:grpSpPr>
            <p:sp>
              <p:nvSpPr>
                <p:cNvPr id="199" name=""/>
                <p:cNvSpPr/>
                <p:nvPr/>
              </p:nvSpPr>
              <p:spPr>
                <a:xfrm>
                  <a:off x="488952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00" name=""/>
                <p:cNvSpPr/>
                <p:nvPr/>
              </p:nvSpPr>
              <p:spPr>
                <a:xfrm>
                  <a:off x="496548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201" name=""/>
            <p:cNvSpPr/>
            <p:nvPr/>
          </p:nvSpPr>
          <p:spPr>
            <a:xfrm>
              <a:off x="4919760" y="3886200"/>
              <a:ext cx="178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02" name=""/>
          <p:cNvSpPr/>
          <p:nvPr/>
        </p:nvSpPr>
        <p:spPr>
          <a:xfrm>
            <a:off x="3910320" y="38559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4119840" y="38559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>
            <a:off x="4345200" y="38559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4640400" y="38559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4849920" y="38559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/>
          <p:cNvSpPr/>
          <p:nvPr/>
        </p:nvSpPr>
        <p:spPr>
          <a:xfrm>
            <a:off x="4062960" y="402588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53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"/>
          <p:cNvSpPr/>
          <p:nvPr/>
        </p:nvSpPr>
        <p:spPr>
          <a:xfrm>
            <a:off x="4674240" y="402588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67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"/>
          <p:cNvSpPr/>
          <p:nvPr/>
        </p:nvSpPr>
        <p:spPr>
          <a:xfrm>
            <a:off x="4162320" y="1792440"/>
            <a:ext cx="0" cy="211608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"/>
          <p:cNvSpPr/>
          <p:nvPr/>
        </p:nvSpPr>
        <p:spPr>
          <a:xfrm>
            <a:off x="4381560" y="1792440"/>
            <a:ext cx="0" cy="211608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"/>
          <p:cNvSpPr/>
          <p:nvPr/>
        </p:nvSpPr>
        <p:spPr>
          <a:xfrm>
            <a:off x="4614840" y="1792440"/>
            <a:ext cx="0" cy="211608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"/>
          <p:cNvSpPr/>
          <p:nvPr/>
        </p:nvSpPr>
        <p:spPr>
          <a:xfrm>
            <a:off x="4896000" y="1792440"/>
            <a:ext cx="0" cy="211608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"/>
          <p:cNvSpPr/>
          <p:nvPr/>
        </p:nvSpPr>
        <p:spPr>
          <a:xfrm>
            <a:off x="4667400" y="1792440"/>
            <a:ext cx="0" cy="211608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"/>
          <p:cNvSpPr/>
          <p:nvPr/>
        </p:nvSpPr>
        <p:spPr>
          <a:xfrm>
            <a:off x="3800880" y="2679840"/>
            <a:ext cx="112104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B) SCO3217 (</a:t>
            </a: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cdaR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)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"/>
          <p:cNvSpPr/>
          <p:nvPr/>
        </p:nvSpPr>
        <p:spPr>
          <a:xfrm>
            <a:off x="3700080" y="1579680"/>
            <a:ext cx="1383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A) SCO5085 (</a:t>
            </a: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actII-ORF4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)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"/>
          <p:cNvSpPr/>
          <p:nvPr/>
        </p:nvSpPr>
        <p:spPr>
          <a:xfrm>
            <a:off x="274680" y="4602960"/>
            <a:ext cx="89726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ig. S2. qRT-PCR shows transcription of the Act and CDA cluster regulators SCO5085 (panel A) and SCO3217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panel B), respectively, is induced following induction of ppGpp synthesis in M653. In each biological replicate experiment,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1-R3, using strain M653 [</a:t>
            </a:r>
            <a:r>
              <a:rPr b="0" i="1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elA tipAp::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(1.46kb)] or the control strain M667 [</a:t>
            </a:r>
            <a:r>
              <a:rPr b="0" i="1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elA tipAp::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], lane 1corresponds to the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re-induction sample (0 min) and lanes 2 and 3 correspond to the samples taken 60 min (for A) or 90 min (for B) after induction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or non-induction with thiostrepton, respectively. The average of three qRT-PCR determinations is shown, and standard deviations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re marked with error bar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7" name=""/>
          <p:cNvGrpSpPr/>
          <p:nvPr/>
        </p:nvGrpSpPr>
        <p:grpSpPr>
          <a:xfrm>
            <a:off x="3705120" y="1676520"/>
            <a:ext cx="1492200" cy="1059840"/>
            <a:chOff x="3705120" y="1676520"/>
            <a:chExt cx="1492200" cy="1059840"/>
          </a:xfrm>
        </p:grpSpPr>
        <p:grpSp>
          <p:nvGrpSpPr>
            <p:cNvPr id="218" name=""/>
            <p:cNvGrpSpPr/>
            <p:nvPr/>
          </p:nvGrpSpPr>
          <p:grpSpPr>
            <a:xfrm>
              <a:off x="3749400" y="1750680"/>
              <a:ext cx="1447920" cy="985680"/>
              <a:chOff x="3749400" y="1750680"/>
              <a:chExt cx="1447920" cy="985680"/>
            </a:xfrm>
          </p:grpSpPr>
          <p:graphicFrame>
            <p:nvGraphicFramePr>
              <p:cNvPr id="219" name=""/>
              <p:cNvGraphicFramePr/>
              <p:nvPr/>
            </p:nvGraphicFramePr>
            <p:xfrm>
              <a:off x="3749400" y="1750680"/>
              <a:ext cx="1295640" cy="985680"/>
            </p:xfrm>
            <a:graphic>
              <a:graphicData uri="http://schemas.openxmlformats.org/presentationml/2006/ole">
                <p:oleObj progId="Excel.Sheet.12" r:id="rId1" spid="">
                  <p:embed/>
                  <p:pic>
                    <p:nvPicPr>
                      <p:cNvPr id="220" name="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3749400" y="1750680"/>
                        <a:ext cx="1295640" cy="9856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221" name=""/>
              <p:cNvSpPr/>
              <p:nvPr/>
            </p:nvSpPr>
            <p:spPr>
              <a:xfrm>
                <a:off x="3825720" y="2660040"/>
                <a:ext cx="1371600" cy="759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9160" bIns="2916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22" name=""/>
            <p:cNvSpPr/>
            <p:nvPr/>
          </p:nvSpPr>
          <p:spPr>
            <a:xfrm>
              <a:off x="3705120" y="1676520"/>
              <a:ext cx="152280" cy="990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23" name=""/>
          <p:cNvSpPr/>
          <p:nvPr/>
        </p:nvSpPr>
        <p:spPr>
          <a:xfrm>
            <a:off x="3749760" y="2666880"/>
            <a:ext cx="1371600" cy="76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520" bIns="295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"/>
          <p:cNvSpPr/>
          <p:nvPr/>
        </p:nvSpPr>
        <p:spPr>
          <a:xfrm>
            <a:off x="3714840" y="1676520"/>
            <a:ext cx="152280" cy="9903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25" name=""/>
          <p:cNvGrpSpPr/>
          <p:nvPr/>
        </p:nvGrpSpPr>
        <p:grpSpPr>
          <a:xfrm>
            <a:off x="3679920" y="2879640"/>
            <a:ext cx="1447560" cy="1067040"/>
            <a:chOff x="3679920" y="2879640"/>
            <a:chExt cx="1447560" cy="1067040"/>
          </a:xfrm>
        </p:grpSpPr>
        <p:grpSp>
          <p:nvGrpSpPr>
            <p:cNvPr id="226" name=""/>
            <p:cNvGrpSpPr/>
            <p:nvPr/>
          </p:nvGrpSpPr>
          <p:grpSpPr>
            <a:xfrm>
              <a:off x="3679920" y="2879640"/>
              <a:ext cx="1447560" cy="1067040"/>
              <a:chOff x="3679920" y="2879640"/>
              <a:chExt cx="1447560" cy="1067040"/>
            </a:xfrm>
          </p:grpSpPr>
          <p:graphicFrame>
            <p:nvGraphicFramePr>
              <p:cNvPr id="227" name=""/>
              <p:cNvGraphicFramePr/>
              <p:nvPr/>
            </p:nvGraphicFramePr>
            <p:xfrm>
              <a:off x="3755880" y="2879640"/>
              <a:ext cx="1294920" cy="986040"/>
            </p:xfrm>
            <a:graphic>
              <a:graphicData uri="http://schemas.openxmlformats.org/presentationml/2006/ole">
                <p:oleObj progId="Excel.Sheet.12" r:id="rId3" spid="">
                  <p:embed/>
                  <p:pic>
                    <p:nvPicPr>
                      <p:cNvPr id="228" name="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3755880" y="2879640"/>
                        <a:ext cx="1294920" cy="98604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229" name=""/>
              <p:cNvSpPr/>
              <p:nvPr/>
            </p:nvSpPr>
            <p:spPr>
              <a:xfrm>
                <a:off x="3679920" y="3794040"/>
                <a:ext cx="1447560" cy="152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30" name=""/>
            <p:cNvSpPr/>
            <p:nvPr/>
          </p:nvSpPr>
          <p:spPr>
            <a:xfrm>
              <a:off x="3708360" y="2879640"/>
              <a:ext cx="151920" cy="990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31" name=""/>
          <p:cNvSpPr/>
          <p:nvPr/>
        </p:nvSpPr>
        <p:spPr>
          <a:xfrm rot="16200000">
            <a:off x="2774520" y="2784240"/>
            <a:ext cx="167724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rmalized transcript abundanc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32" name=""/>
          <p:cNvGrpSpPr/>
          <p:nvPr/>
        </p:nvGrpSpPr>
        <p:grpSpPr>
          <a:xfrm>
            <a:off x="3786840" y="3733920"/>
            <a:ext cx="375120" cy="200520"/>
            <a:chOff x="3786840" y="3733920"/>
            <a:chExt cx="375120" cy="200520"/>
          </a:xfrm>
        </p:grpSpPr>
        <p:grpSp>
          <p:nvGrpSpPr>
            <p:cNvPr id="233" name=""/>
            <p:cNvGrpSpPr/>
            <p:nvPr/>
          </p:nvGrpSpPr>
          <p:grpSpPr>
            <a:xfrm>
              <a:off x="3786840" y="3733920"/>
              <a:ext cx="375120" cy="200520"/>
              <a:chOff x="3786840" y="3733920"/>
              <a:chExt cx="375120" cy="200520"/>
            </a:xfrm>
          </p:grpSpPr>
          <p:sp>
            <p:nvSpPr>
              <p:cNvPr id="234" name=""/>
              <p:cNvSpPr/>
              <p:nvPr/>
            </p:nvSpPr>
            <p:spPr>
              <a:xfrm>
                <a:off x="3786840" y="37339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235" name=""/>
              <p:cNvGrpSpPr/>
              <p:nvPr/>
            </p:nvGrpSpPr>
            <p:grpSpPr>
              <a:xfrm>
                <a:off x="3856680" y="3733920"/>
                <a:ext cx="305280" cy="200520"/>
                <a:chOff x="3856680" y="3733920"/>
                <a:chExt cx="305280" cy="200520"/>
              </a:xfrm>
            </p:grpSpPr>
            <p:sp>
              <p:nvSpPr>
                <p:cNvPr id="236" name=""/>
                <p:cNvSpPr/>
                <p:nvPr/>
              </p:nvSpPr>
              <p:spPr>
                <a:xfrm>
                  <a:off x="385668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37" name=""/>
                <p:cNvSpPr/>
                <p:nvPr/>
              </p:nvSpPr>
              <p:spPr>
                <a:xfrm>
                  <a:off x="393264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238" name=""/>
            <p:cNvSpPr/>
            <p:nvPr/>
          </p:nvSpPr>
          <p:spPr>
            <a:xfrm>
              <a:off x="3886560" y="3886200"/>
              <a:ext cx="17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239" name=""/>
          <p:cNvGrpSpPr/>
          <p:nvPr/>
        </p:nvGrpSpPr>
        <p:grpSpPr>
          <a:xfrm>
            <a:off x="4007520" y="3733920"/>
            <a:ext cx="375120" cy="200520"/>
            <a:chOff x="4007520" y="3733920"/>
            <a:chExt cx="375120" cy="200520"/>
          </a:xfrm>
        </p:grpSpPr>
        <p:grpSp>
          <p:nvGrpSpPr>
            <p:cNvPr id="240" name=""/>
            <p:cNvGrpSpPr/>
            <p:nvPr/>
          </p:nvGrpSpPr>
          <p:grpSpPr>
            <a:xfrm>
              <a:off x="4007520" y="3733920"/>
              <a:ext cx="375120" cy="200520"/>
              <a:chOff x="4007520" y="3733920"/>
              <a:chExt cx="375120" cy="200520"/>
            </a:xfrm>
          </p:grpSpPr>
          <p:sp>
            <p:nvSpPr>
              <p:cNvPr id="241" name=""/>
              <p:cNvSpPr/>
              <p:nvPr/>
            </p:nvSpPr>
            <p:spPr>
              <a:xfrm>
                <a:off x="4007520" y="37339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242" name=""/>
              <p:cNvGrpSpPr/>
              <p:nvPr/>
            </p:nvGrpSpPr>
            <p:grpSpPr>
              <a:xfrm>
                <a:off x="4077360" y="3733920"/>
                <a:ext cx="305280" cy="200520"/>
                <a:chOff x="4077360" y="3733920"/>
                <a:chExt cx="305280" cy="200520"/>
              </a:xfrm>
            </p:grpSpPr>
            <p:sp>
              <p:nvSpPr>
                <p:cNvPr id="243" name=""/>
                <p:cNvSpPr/>
                <p:nvPr/>
              </p:nvSpPr>
              <p:spPr>
                <a:xfrm>
                  <a:off x="407736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44" name=""/>
                <p:cNvSpPr/>
                <p:nvPr/>
              </p:nvSpPr>
              <p:spPr>
                <a:xfrm>
                  <a:off x="415332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245" name=""/>
            <p:cNvSpPr/>
            <p:nvPr/>
          </p:nvSpPr>
          <p:spPr>
            <a:xfrm>
              <a:off x="4107240" y="3886200"/>
              <a:ext cx="17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246" name=""/>
          <p:cNvGrpSpPr/>
          <p:nvPr/>
        </p:nvGrpSpPr>
        <p:grpSpPr>
          <a:xfrm>
            <a:off x="4231080" y="3733920"/>
            <a:ext cx="374760" cy="200520"/>
            <a:chOff x="4231080" y="3733920"/>
            <a:chExt cx="374760" cy="200520"/>
          </a:xfrm>
        </p:grpSpPr>
        <p:grpSp>
          <p:nvGrpSpPr>
            <p:cNvPr id="247" name=""/>
            <p:cNvGrpSpPr/>
            <p:nvPr/>
          </p:nvGrpSpPr>
          <p:grpSpPr>
            <a:xfrm>
              <a:off x="4231080" y="3733920"/>
              <a:ext cx="374760" cy="200520"/>
              <a:chOff x="4231080" y="3733920"/>
              <a:chExt cx="374760" cy="200520"/>
            </a:xfrm>
          </p:grpSpPr>
          <p:sp>
            <p:nvSpPr>
              <p:cNvPr id="248" name=""/>
              <p:cNvSpPr/>
              <p:nvPr/>
            </p:nvSpPr>
            <p:spPr>
              <a:xfrm>
                <a:off x="4231080" y="37339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249" name=""/>
              <p:cNvGrpSpPr/>
              <p:nvPr/>
            </p:nvGrpSpPr>
            <p:grpSpPr>
              <a:xfrm>
                <a:off x="4300560" y="3733920"/>
                <a:ext cx="305280" cy="200520"/>
                <a:chOff x="4300560" y="3733920"/>
                <a:chExt cx="305280" cy="200520"/>
              </a:xfrm>
            </p:grpSpPr>
            <p:sp>
              <p:nvSpPr>
                <p:cNvPr id="250" name=""/>
                <p:cNvSpPr/>
                <p:nvPr/>
              </p:nvSpPr>
              <p:spPr>
                <a:xfrm>
                  <a:off x="430056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51" name=""/>
                <p:cNvSpPr/>
                <p:nvPr/>
              </p:nvSpPr>
              <p:spPr>
                <a:xfrm>
                  <a:off x="437652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252" name=""/>
            <p:cNvSpPr/>
            <p:nvPr/>
          </p:nvSpPr>
          <p:spPr>
            <a:xfrm>
              <a:off x="4330800" y="3886200"/>
              <a:ext cx="178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253" name=""/>
          <p:cNvGrpSpPr/>
          <p:nvPr/>
        </p:nvGrpSpPr>
        <p:grpSpPr>
          <a:xfrm>
            <a:off x="4523400" y="3733920"/>
            <a:ext cx="375120" cy="200520"/>
            <a:chOff x="4523400" y="3733920"/>
            <a:chExt cx="375120" cy="200520"/>
          </a:xfrm>
        </p:grpSpPr>
        <p:grpSp>
          <p:nvGrpSpPr>
            <p:cNvPr id="254" name=""/>
            <p:cNvGrpSpPr/>
            <p:nvPr/>
          </p:nvGrpSpPr>
          <p:grpSpPr>
            <a:xfrm>
              <a:off x="4523400" y="3733920"/>
              <a:ext cx="375120" cy="200520"/>
              <a:chOff x="4523400" y="3733920"/>
              <a:chExt cx="375120" cy="200520"/>
            </a:xfrm>
          </p:grpSpPr>
          <p:sp>
            <p:nvSpPr>
              <p:cNvPr id="255" name=""/>
              <p:cNvSpPr/>
              <p:nvPr/>
            </p:nvSpPr>
            <p:spPr>
              <a:xfrm>
                <a:off x="4523400" y="37339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256" name=""/>
              <p:cNvGrpSpPr/>
              <p:nvPr/>
            </p:nvGrpSpPr>
            <p:grpSpPr>
              <a:xfrm>
                <a:off x="4593240" y="3733920"/>
                <a:ext cx="305280" cy="200520"/>
                <a:chOff x="4593240" y="3733920"/>
                <a:chExt cx="305280" cy="200520"/>
              </a:xfrm>
            </p:grpSpPr>
            <p:sp>
              <p:nvSpPr>
                <p:cNvPr id="257" name=""/>
                <p:cNvSpPr/>
                <p:nvPr/>
              </p:nvSpPr>
              <p:spPr>
                <a:xfrm>
                  <a:off x="459324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58" name=""/>
                <p:cNvSpPr/>
                <p:nvPr/>
              </p:nvSpPr>
              <p:spPr>
                <a:xfrm>
                  <a:off x="466920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259" name=""/>
            <p:cNvSpPr/>
            <p:nvPr/>
          </p:nvSpPr>
          <p:spPr>
            <a:xfrm>
              <a:off x="4623120" y="3886200"/>
              <a:ext cx="17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260" name=""/>
          <p:cNvGrpSpPr/>
          <p:nvPr/>
        </p:nvGrpSpPr>
        <p:grpSpPr>
          <a:xfrm>
            <a:off x="4744080" y="3733920"/>
            <a:ext cx="375120" cy="200520"/>
            <a:chOff x="4744080" y="3733920"/>
            <a:chExt cx="375120" cy="200520"/>
          </a:xfrm>
        </p:grpSpPr>
        <p:grpSp>
          <p:nvGrpSpPr>
            <p:cNvPr id="261" name=""/>
            <p:cNvGrpSpPr/>
            <p:nvPr/>
          </p:nvGrpSpPr>
          <p:grpSpPr>
            <a:xfrm>
              <a:off x="4744080" y="3733920"/>
              <a:ext cx="375120" cy="200520"/>
              <a:chOff x="4744080" y="3733920"/>
              <a:chExt cx="375120" cy="200520"/>
            </a:xfrm>
          </p:grpSpPr>
          <p:sp>
            <p:nvSpPr>
              <p:cNvPr id="262" name=""/>
              <p:cNvSpPr/>
              <p:nvPr/>
            </p:nvSpPr>
            <p:spPr>
              <a:xfrm>
                <a:off x="4744080" y="373392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263" name=""/>
              <p:cNvGrpSpPr/>
              <p:nvPr/>
            </p:nvGrpSpPr>
            <p:grpSpPr>
              <a:xfrm>
                <a:off x="4813920" y="3733920"/>
                <a:ext cx="305280" cy="200520"/>
                <a:chOff x="4813920" y="3733920"/>
                <a:chExt cx="305280" cy="200520"/>
              </a:xfrm>
            </p:grpSpPr>
            <p:sp>
              <p:nvSpPr>
                <p:cNvPr id="264" name=""/>
                <p:cNvSpPr/>
                <p:nvPr/>
              </p:nvSpPr>
              <p:spPr>
                <a:xfrm>
                  <a:off x="481392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65" name=""/>
                <p:cNvSpPr/>
                <p:nvPr/>
              </p:nvSpPr>
              <p:spPr>
                <a:xfrm>
                  <a:off x="4889880" y="373392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sp>
          <p:nvSpPr>
            <p:cNvPr id="266" name=""/>
            <p:cNvSpPr/>
            <p:nvPr/>
          </p:nvSpPr>
          <p:spPr>
            <a:xfrm>
              <a:off x="4843800" y="3886200"/>
              <a:ext cx="17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67" name=""/>
          <p:cNvSpPr/>
          <p:nvPr/>
        </p:nvSpPr>
        <p:spPr>
          <a:xfrm>
            <a:off x="3834000" y="38559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8" name=""/>
          <p:cNvSpPr/>
          <p:nvPr/>
        </p:nvSpPr>
        <p:spPr>
          <a:xfrm>
            <a:off x="4043520" y="38559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9" name=""/>
          <p:cNvSpPr/>
          <p:nvPr/>
        </p:nvSpPr>
        <p:spPr>
          <a:xfrm>
            <a:off x="4268880" y="38559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0" name=""/>
          <p:cNvSpPr/>
          <p:nvPr/>
        </p:nvSpPr>
        <p:spPr>
          <a:xfrm>
            <a:off x="4564440" y="38559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1" name=""/>
          <p:cNvSpPr/>
          <p:nvPr/>
        </p:nvSpPr>
        <p:spPr>
          <a:xfrm>
            <a:off x="4773960" y="385596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2" name=""/>
          <p:cNvSpPr/>
          <p:nvPr/>
        </p:nvSpPr>
        <p:spPr>
          <a:xfrm>
            <a:off x="3986640" y="402588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53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3" name=""/>
          <p:cNvSpPr/>
          <p:nvPr/>
        </p:nvSpPr>
        <p:spPr>
          <a:xfrm>
            <a:off x="4597920" y="402588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67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4" name=""/>
          <p:cNvSpPr/>
          <p:nvPr/>
        </p:nvSpPr>
        <p:spPr>
          <a:xfrm>
            <a:off x="4086360" y="1792440"/>
            <a:ext cx="0" cy="211608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5" name=""/>
          <p:cNvSpPr/>
          <p:nvPr/>
        </p:nvSpPr>
        <p:spPr>
          <a:xfrm>
            <a:off x="4305240" y="1792440"/>
            <a:ext cx="0" cy="211608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6" name=""/>
          <p:cNvSpPr/>
          <p:nvPr/>
        </p:nvSpPr>
        <p:spPr>
          <a:xfrm>
            <a:off x="4538520" y="1792440"/>
            <a:ext cx="0" cy="211608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7" name=""/>
          <p:cNvSpPr/>
          <p:nvPr/>
        </p:nvSpPr>
        <p:spPr>
          <a:xfrm>
            <a:off x="4819680" y="1792440"/>
            <a:ext cx="0" cy="211608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8" name=""/>
          <p:cNvSpPr/>
          <p:nvPr/>
        </p:nvSpPr>
        <p:spPr>
          <a:xfrm>
            <a:off x="4591080" y="1792440"/>
            <a:ext cx="0" cy="211608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9" name=""/>
          <p:cNvSpPr/>
          <p:nvPr/>
        </p:nvSpPr>
        <p:spPr>
          <a:xfrm>
            <a:off x="3688560" y="2679840"/>
            <a:ext cx="787320" cy="215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B) SCO4336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0" name=""/>
          <p:cNvSpPr/>
          <p:nvPr/>
        </p:nvSpPr>
        <p:spPr>
          <a:xfrm>
            <a:off x="3688560" y="1579680"/>
            <a:ext cx="78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) SCO4198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1" name=""/>
          <p:cNvSpPr/>
          <p:nvPr/>
        </p:nvSpPr>
        <p:spPr>
          <a:xfrm>
            <a:off x="198360" y="4602960"/>
            <a:ext cx="89726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ig. S3. qRT-PCR shows transcription of the regulatory genes SC04198 (panel A) and SCO4336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panel B), respectively, is induced following induction of ppGpp synthesis in M653. In each biological replicate experiment,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R1-R3, using strain M653 [</a:t>
            </a:r>
            <a:r>
              <a:rPr b="0" i="1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elA tipAp::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(1.46kb)] or the control strain M667 [</a:t>
            </a:r>
            <a:r>
              <a:rPr b="0" i="1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elA tipAp::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], lane 1corresponds to the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pre-induction sample (0 min) and lanes 2 and 3 correspond to the samples taken 90 min after induction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or non-induction with thiostrepton, respectively. The average of three qRT-PCR determinations is shown, and standard deviations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re marked with error bar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2" name=""/>
          <p:cNvGrpSpPr/>
          <p:nvPr/>
        </p:nvGrpSpPr>
        <p:grpSpPr>
          <a:xfrm>
            <a:off x="3733920" y="1963800"/>
            <a:ext cx="1447560" cy="1041480"/>
            <a:chOff x="3733920" y="1963800"/>
            <a:chExt cx="1447560" cy="1041480"/>
          </a:xfrm>
        </p:grpSpPr>
        <p:graphicFrame>
          <p:nvGraphicFramePr>
            <p:cNvPr id="283" name=""/>
            <p:cNvGraphicFramePr/>
            <p:nvPr/>
          </p:nvGraphicFramePr>
          <p:xfrm>
            <a:off x="3809880" y="2017800"/>
            <a:ext cx="1295640" cy="98604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284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809880" y="2017800"/>
                      <a:ext cx="1295640" cy="986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285" name=""/>
            <p:cNvSpPr/>
            <p:nvPr/>
          </p:nvSpPr>
          <p:spPr>
            <a:xfrm>
              <a:off x="3733920" y="2929320"/>
              <a:ext cx="1447560" cy="75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9160" bIns="291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3755880" y="1963800"/>
              <a:ext cx="152640" cy="990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87" name=""/>
          <p:cNvSpPr/>
          <p:nvPr/>
        </p:nvSpPr>
        <p:spPr>
          <a:xfrm rot="16200000">
            <a:off x="3022920" y="2339280"/>
            <a:ext cx="117432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Normalized transcript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abundanc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88" name=""/>
          <p:cNvGrpSpPr/>
          <p:nvPr/>
        </p:nvGrpSpPr>
        <p:grpSpPr>
          <a:xfrm>
            <a:off x="4478400" y="2879640"/>
            <a:ext cx="409320" cy="200520"/>
            <a:chOff x="4478400" y="2879640"/>
            <a:chExt cx="409320" cy="200520"/>
          </a:xfrm>
        </p:grpSpPr>
        <p:sp>
          <p:nvSpPr>
            <p:cNvPr id="289" name=""/>
            <p:cNvSpPr/>
            <p:nvPr/>
          </p:nvSpPr>
          <p:spPr>
            <a:xfrm>
              <a:off x="4478400" y="287964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4539240" y="287964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4609800" y="287964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4552560" y="303192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93" name=""/>
          <p:cNvSpPr/>
          <p:nvPr/>
        </p:nvSpPr>
        <p:spPr>
          <a:xfrm>
            <a:off x="3926160" y="301608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4" name=""/>
          <p:cNvSpPr/>
          <p:nvPr/>
        </p:nvSpPr>
        <p:spPr>
          <a:xfrm>
            <a:off x="4173840" y="301608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5" name=""/>
          <p:cNvSpPr/>
          <p:nvPr/>
        </p:nvSpPr>
        <p:spPr>
          <a:xfrm>
            <a:off x="4538880" y="301608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6" name=""/>
          <p:cNvSpPr/>
          <p:nvPr/>
        </p:nvSpPr>
        <p:spPr>
          <a:xfrm>
            <a:off x="4802400" y="3016080"/>
            <a:ext cx="31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R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7" name=""/>
          <p:cNvSpPr/>
          <p:nvPr/>
        </p:nvSpPr>
        <p:spPr>
          <a:xfrm>
            <a:off x="3970800" y="318600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53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8" name=""/>
          <p:cNvSpPr/>
          <p:nvPr/>
        </p:nvSpPr>
        <p:spPr>
          <a:xfrm>
            <a:off x="4604400" y="3186000"/>
            <a:ext cx="46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67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9" name=""/>
          <p:cNvSpPr/>
          <p:nvPr/>
        </p:nvSpPr>
        <p:spPr>
          <a:xfrm>
            <a:off x="4191120" y="204804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0" name=""/>
          <p:cNvSpPr/>
          <p:nvPr/>
        </p:nvSpPr>
        <p:spPr>
          <a:xfrm>
            <a:off x="4478400" y="204804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1" name=""/>
          <p:cNvSpPr/>
          <p:nvPr/>
        </p:nvSpPr>
        <p:spPr>
          <a:xfrm>
            <a:off x="4816440" y="204804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2" name=""/>
          <p:cNvSpPr/>
          <p:nvPr/>
        </p:nvSpPr>
        <p:spPr>
          <a:xfrm>
            <a:off x="4530600" y="2048040"/>
            <a:ext cx="0" cy="107316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303" name=""/>
          <p:cNvGrpSpPr/>
          <p:nvPr/>
        </p:nvGrpSpPr>
        <p:grpSpPr>
          <a:xfrm>
            <a:off x="4756320" y="2879640"/>
            <a:ext cx="409320" cy="200520"/>
            <a:chOff x="4756320" y="2879640"/>
            <a:chExt cx="409320" cy="200520"/>
          </a:xfrm>
        </p:grpSpPr>
        <p:sp>
          <p:nvSpPr>
            <p:cNvPr id="304" name=""/>
            <p:cNvSpPr/>
            <p:nvPr/>
          </p:nvSpPr>
          <p:spPr>
            <a:xfrm>
              <a:off x="4756320" y="287964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4817160" y="287964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4887720" y="287964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4830480" y="303192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08" name=""/>
          <p:cNvGrpSpPr/>
          <p:nvPr/>
        </p:nvGrpSpPr>
        <p:grpSpPr>
          <a:xfrm>
            <a:off x="3843720" y="2878200"/>
            <a:ext cx="408600" cy="200520"/>
            <a:chOff x="3843720" y="2878200"/>
            <a:chExt cx="408600" cy="200520"/>
          </a:xfrm>
        </p:grpSpPr>
        <p:sp>
          <p:nvSpPr>
            <p:cNvPr id="309" name=""/>
            <p:cNvSpPr/>
            <p:nvPr/>
          </p:nvSpPr>
          <p:spPr>
            <a:xfrm>
              <a:off x="3843720" y="287820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3903840" y="287820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3974400" y="287820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3917520" y="3030480"/>
              <a:ext cx="252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13" name=""/>
          <p:cNvGrpSpPr/>
          <p:nvPr/>
        </p:nvGrpSpPr>
        <p:grpSpPr>
          <a:xfrm>
            <a:off x="4125960" y="2879640"/>
            <a:ext cx="409320" cy="200520"/>
            <a:chOff x="4125960" y="2879640"/>
            <a:chExt cx="409320" cy="200520"/>
          </a:xfrm>
        </p:grpSpPr>
        <p:sp>
          <p:nvSpPr>
            <p:cNvPr id="314" name=""/>
            <p:cNvSpPr/>
            <p:nvPr/>
          </p:nvSpPr>
          <p:spPr>
            <a:xfrm>
              <a:off x="4125960" y="2879640"/>
              <a:ext cx="2293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4186800" y="2879640"/>
              <a:ext cx="2538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4257360" y="2879640"/>
              <a:ext cx="277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4200120" y="3031920"/>
              <a:ext cx="252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18" name=""/>
          <p:cNvSpPr/>
          <p:nvPr/>
        </p:nvSpPr>
        <p:spPr>
          <a:xfrm>
            <a:off x="4114440" y="1752480"/>
            <a:ext cx="73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CO626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9" name=""/>
          <p:cNvSpPr/>
          <p:nvPr/>
        </p:nvSpPr>
        <p:spPr>
          <a:xfrm>
            <a:off x="-8640" y="4693680"/>
            <a:ext cx="91587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ig. S4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qRT-PCR analysis confirms that transcription of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CO6264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is induced following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induction of ppGpp synthesis in M653 [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relA tipAp::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(1.46kb)] but unaffected in the control strain M667 [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relA tipAp::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].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In each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iological replicate experiment, R1-R2, lane 1corresponds to the pre-induction sample (0 min) and lanes 2 and 3 correspond to the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amples taken 60 min after induction or non-induction with thiostrepton, respectively. The average of three qRT-PCR determinations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is shown, and standard deviations are marked with error bars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0" name=""/>
          <p:cNvGrpSpPr/>
          <p:nvPr/>
        </p:nvGrpSpPr>
        <p:grpSpPr>
          <a:xfrm>
            <a:off x="3429000" y="950760"/>
            <a:ext cx="1087560" cy="1730160"/>
            <a:chOff x="3429000" y="950760"/>
            <a:chExt cx="1087560" cy="1730160"/>
          </a:xfrm>
        </p:grpSpPr>
        <p:pic>
          <p:nvPicPr>
            <p:cNvPr id="321" name="" descr=""/>
            <p:cNvPicPr/>
            <p:nvPr/>
          </p:nvPicPr>
          <p:blipFill>
            <a:blip r:embed="rId1"/>
            <a:stretch/>
          </p:blipFill>
          <p:spPr>
            <a:xfrm>
              <a:off x="3429000" y="1376280"/>
              <a:ext cx="1079640" cy="10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22" name=""/>
            <p:cNvSpPr/>
            <p:nvPr/>
          </p:nvSpPr>
          <p:spPr>
            <a:xfrm>
              <a:off x="3512160" y="122400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5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4016880" y="122400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3510000" y="249552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4046400" y="2495520"/>
              <a:ext cx="43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3430080" y="24955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3972960" y="249408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3998880" y="1392120"/>
              <a:ext cx="0" cy="9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3486240" y="950760"/>
              <a:ext cx="1017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coelichelin</a:t>
              </a:r>
              <a:r>
                <a:rPr b="0" i="1" lang="en-GB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cluster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(SCO0489-99)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30" name=""/>
          <p:cNvGrpSpPr/>
          <p:nvPr/>
        </p:nvGrpSpPr>
        <p:grpSpPr>
          <a:xfrm>
            <a:off x="392760" y="950760"/>
            <a:ext cx="1357200" cy="1730160"/>
            <a:chOff x="392760" y="950760"/>
            <a:chExt cx="1357200" cy="1730160"/>
          </a:xfrm>
        </p:grpSpPr>
        <p:pic>
          <p:nvPicPr>
            <p:cNvPr id="331" name="" descr=""/>
            <p:cNvPicPr/>
            <p:nvPr/>
          </p:nvPicPr>
          <p:blipFill>
            <a:blip r:embed="rId2"/>
            <a:stretch/>
          </p:blipFill>
          <p:spPr>
            <a:xfrm>
              <a:off x="506160" y="1373040"/>
              <a:ext cx="1079280" cy="10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32" name=""/>
            <p:cNvSpPr/>
            <p:nvPr/>
          </p:nvSpPr>
          <p:spPr>
            <a:xfrm>
              <a:off x="589320" y="122364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5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1094040" y="122364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587160" y="249552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1123920" y="2495520"/>
              <a:ext cx="43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507240" y="24955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1050120" y="24937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1076040" y="1392120"/>
              <a:ext cx="0" cy="9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392760" y="950760"/>
              <a:ext cx="1357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Eicosapentanoate</a:t>
              </a:r>
              <a:r>
                <a:rPr b="0" i="1" lang="en-GB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cluster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(SCO0124-29)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40" name=""/>
          <p:cNvGrpSpPr/>
          <p:nvPr/>
        </p:nvGrpSpPr>
        <p:grpSpPr>
          <a:xfrm>
            <a:off x="7445520" y="950760"/>
            <a:ext cx="1087560" cy="1730160"/>
            <a:chOff x="7445520" y="950760"/>
            <a:chExt cx="1087560" cy="1730160"/>
          </a:xfrm>
        </p:grpSpPr>
        <p:pic>
          <p:nvPicPr>
            <p:cNvPr id="341" name="" descr=""/>
            <p:cNvPicPr/>
            <p:nvPr/>
          </p:nvPicPr>
          <p:blipFill>
            <a:blip r:embed="rId3"/>
            <a:stretch/>
          </p:blipFill>
          <p:spPr>
            <a:xfrm>
              <a:off x="7445520" y="1374840"/>
              <a:ext cx="107964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42" name=""/>
            <p:cNvSpPr/>
            <p:nvPr/>
          </p:nvSpPr>
          <p:spPr>
            <a:xfrm>
              <a:off x="7528680" y="122400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5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8033400" y="122400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7526520" y="2495520"/>
              <a:ext cx="43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8063280" y="249552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7446600" y="24955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7989480" y="24937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8015400" y="1392120"/>
              <a:ext cx="0" cy="9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7498080" y="950760"/>
              <a:ext cx="1026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Hopanoids</a:t>
              </a:r>
              <a:r>
                <a:rPr b="0" i="1" lang="en-GB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cluster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(SCO6759-61)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50" name=""/>
          <p:cNvGrpSpPr/>
          <p:nvPr/>
        </p:nvGrpSpPr>
        <p:grpSpPr>
          <a:xfrm>
            <a:off x="4801680" y="950760"/>
            <a:ext cx="1086480" cy="1730160"/>
            <a:chOff x="4801680" y="950760"/>
            <a:chExt cx="1086480" cy="1730160"/>
          </a:xfrm>
        </p:grpSpPr>
        <p:pic>
          <p:nvPicPr>
            <p:cNvPr id="351" name="" descr=""/>
            <p:cNvPicPr/>
            <p:nvPr/>
          </p:nvPicPr>
          <p:blipFill>
            <a:blip r:embed="rId4"/>
            <a:stretch/>
          </p:blipFill>
          <p:spPr>
            <a:xfrm>
              <a:off x="4803840" y="1374840"/>
              <a:ext cx="107928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52" name=""/>
            <p:cNvSpPr/>
            <p:nvPr/>
          </p:nvSpPr>
          <p:spPr>
            <a:xfrm>
              <a:off x="4883760" y="122400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5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5388480" y="122400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4881600" y="249552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5418000" y="2495520"/>
              <a:ext cx="43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4801680" y="24955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5344560" y="24937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5370480" y="1392120"/>
              <a:ext cx="0" cy="9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4930920" y="950760"/>
              <a:ext cx="869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DA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luster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(SCO3210-49)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60" name=""/>
          <p:cNvGrpSpPr/>
          <p:nvPr/>
        </p:nvGrpSpPr>
        <p:grpSpPr>
          <a:xfrm>
            <a:off x="6067080" y="950760"/>
            <a:ext cx="1096560" cy="1730160"/>
            <a:chOff x="6067080" y="950760"/>
            <a:chExt cx="1096560" cy="1730160"/>
          </a:xfrm>
        </p:grpSpPr>
        <p:pic>
          <p:nvPicPr>
            <p:cNvPr id="361" name="" descr=""/>
            <p:cNvPicPr/>
            <p:nvPr/>
          </p:nvPicPr>
          <p:blipFill>
            <a:blip r:embed="rId5"/>
            <a:stretch/>
          </p:blipFill>
          <p:spPr>
            <a:xfrm>
              <a:off x="6069240" y="1377720"/>
              <a:ext cx="1079280" cy="10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62" name=""/>
            <p:cNvSpPr/>
            <p:nvPr/>
          </p:nvSpPr>
          <p:spPr>
            <a:xfrm>
              <a:off x="6149160" y="122400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5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6653880" y="122400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6147000" y="249552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6683400" y="2495520"/>
              <a:ext cx="43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6067080" y="24955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6609960" y="24937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6635880" y="1392120"/>
              <a:ext cx="0" cy="9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6103440" y="950760"/>
              <a:ext cx="1060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ype I PKS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luster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(SCO6273-88)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70" name=""/>
          <p:cNvGrpSpPr/>
          <p:nvPr/>
        </p:nvGrpSpPr>
        <p:grpSpPr>
          <a:xfrm>
            <a:off x="1752840" y="950760"/>
            <a:ext cx="1523520" cy="1730160"/>
            <a:chOff x="1752840" y="950760"/>
            <a:chExt cx="1523520" cy="1730160"/>
          </a:xfrm>
        </p:grpSpPr>
        <p:pic>
          <p:nvPicPr>
            <p:cNvPr id="371" name="" descr=""/>
            <p:cNvPicPr/>
            <p:nvPr/>
          </p:nvPicPr>
          <p:blipFill>
            <a:blip r:embed="rId6"/>
            <a:stretch/>
          </p:blipFill>
          <p:spPr>
            <a:xfrm>
              <a:off x="1950840" y="1374840"/>
              <a:ext cx="107964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72" name=""/>
            <p:cNvSpPr/>
            <p:nvPr/>
          </p:nvSpPr>
          <p:spPr>
            <a:xfrm>
              <a:off x="2031120" y="122400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5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2535840" y="122400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2028960" y="249552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2565360" y="249552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1949040" y="24955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2491920" y="24937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2517840" y="1392120"/>
              <a:ext cx="0" cy="9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1752840" y="950760"/>
              <a:ext cx="1523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Deoxysugar synthase</a:t>
              </a:r>
              <a:r>
                <a:rPr b="0" i="1" lang="en-GB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cluster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(SCO0381-0401)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80" name=""/>
          <p:cNvGrpSpPr/>
          <p:nvPr/>
        </p:nvGrpSpPr>
        <p:grpSpPr>
          <a:xfrm>
            <a:off x="6066000" y="2919240"/>
            <a:ext cx="1097640" cy="1730160"/>
            <a:chOff x="6066000" y="2919240"/>
            <a:chExt cx="1097640" cy="1730160"/>
          </a:xfrm>
        </p:grpSpPr>
        <p:pic>
          <p:nvPicPr>
            <p:cNvPr id="381" name="" descr=""/>
            <p:cNvPicPr/>
            <p:nvPr/>
          </p:nvPicPr>
          <p:blipFill>
            <a:blip r:embed="rId7"/>
            <a:stretch/>
          </p:blipFill>
          <p:spPr>
            <a:xfrm>
              <a:off x="6066000" y="3344760"/>
              <a:ext cx="107964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82" name=""/>
            <p:cNvSpPr/>
            <p:nvPr/>
          </p:nvSpPr>
          <p:spPr>
            <a:xfrm>
              <a:off x="6149160" y="319212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5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6653880" y="319212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6147000" y="446400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6683400" y="4464000"/>
              <a:ext cx="43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6067080" y="446400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6609960" y="446220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6635880" y="3360600"/>
              <a:ext cx="0" cy="9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6103440" y="2919240"/>
              <a:ext cx="1060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ype I PKS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luster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(SCO6273-88)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390" name=""/>
          <p:cNvGrpSpPr/>
          <p:nvPr/>
        </p:nvGrpSpPr>
        <p:grpSpPr>
          <a:xfrm>
            <a:off x="4809600" y="2919240"/>
            <a:ext cx="1086480" cy="1730160"/>
            <a:chOff x="4809600" y="2919240"/>
            <a:chExt cx="1086480" cy="1730160"/>
          </a:xfrm>
        </p:grpSpPr>
        <p:pic>
          <p:nvPicPr>
            <p:cNvPr id="391" name="" descr=""/>
            <p:cNvPicPr/>
            <p:nvPr/>
          </p:nvPicPr>
          <p:blipFill>
            <a:blip r:embed="rId8"/>
            <a:stretch/>
          </p:blipFill>
          <p:spPr>
            <a:xfrm>
              <a:off x="4811400" y="3343320"/>
              <a:ext cx="107964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92" name=""/>
            <p:cNvSpPr/>
            <p:nvPr/>
          </p:nvSpPr>
          <p:spPr>
            <a:xfrm>
              <a:off x="4891680" y="319248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57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5396400" y="3192480"/>
              <a:ext cx="435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60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4889520" y="446400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5425920" y="446400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4809600" y="446400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5352480" y="446220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5378400" y="3360600"/>
              <a:ext cx="0" cy="9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4938840" y="2919240"/>
              <a:ext cx="869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DA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luster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(SCO3210-49) 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00" name=""/>
          <p:cNvSpPr/>
          <p:nvPr/>
        </p:nvSpPr>
        <p:spPr>
          <a:xfrm>
            <a:off x="443160" y="49680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1" name=""/>
          <p:cNvSpPr/>
          <p:nvPr/>
        </p:nvSpPr>
        <p:spPr>
          <a:xfrm>
            <a:off x="4415040" y="28954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2" name=""/>
          <p:cNvSpPr/>
          <p:nvPr/>
        </p:nvSpPr>
        <p:spPr>
          <a:xfrm>
            <a:off x="510840" y="5047560"/>
            <a:ext cx="8157240" cy="84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ig. S5. Genes from secondary metabolite gene clusters that are significantly differently transcribed between strain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600 (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+ ppGpp+) and M570 (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 ppGpp-). In each panel, the x-axis represents culture age, and the y-axis is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normalized transcript abundance in log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scale. Panels in A are from quality controlled time-course data (8 time points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while those in B display data from all samples taken (12 time points)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"/>
          <p:cNvSpPr/>
          <p:nvPr/>
        </p:nvSpPr>
        <p:spPr>
          <a:xfrm>
            <a:off x="3740760" y="18162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57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4" name=""/>
          <p:cNvSpPr/>
          <p:nvPr/>
        </p:nvSpPr>
        <p:spPr>
          <a:xfrm>
            <a:off x="4245480" y="18162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05" name=""/>
          <p:cNvGrpSpPr/>
          <p:nvPr/>
        </p:nvGrpSpPr>
        <p:grpSpPr>
          <a:xfrm>
            <a:off x="3658680" y="1968480"/>
            <a:ext cx="1086480" cy="1296360"/>
            <a:chOff x="3658680" y="1968480"/>
            <a:chExt cx="1086480" cy="1296360"/>
          </a:xfrm>
        </p:grpSpPr>
        <p:pic>
          <p:nvPicPr>
            <p:cNvPr id="406" name="" descr=""/>
            <p:cNvPicPr/>
            <p:nvPr/>
          </p:nvPicPr>
          <p:blipFill>
            <a:blip r:embed="rId1"/>
            <a:stretch/>
          </p:blipFill>
          <p:spPr>
            <a:xfrm>
              <a:off x="3662280" y="1968480"/>
              <a:ext cx="107964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07" name=""/>
            <p:cNvSpPr/>
            <p:nvPr/>
          </p:nvSpPr>
          <p:spPr>
            <a:xfrm>
              <a:off x="3738600" y="307944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4275000" y="3079440"/>
              <a:ext cx="43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3658680" y="307944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4201560" y="307800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4227480" y="1976040"/>
              <a:ext cx="0" cy="9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12" name=""/>
          <p:cNvSpPr/>
          <p:nvPr/>
        </p:nvSpPr>
        <p:spPr>
          <a:xfrm>
            <a:off x="3784680" y="1542960"/>
            <a:ext cx="898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glgBII 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uster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(SCO7732-38)</a:t>
            </a: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3" name=""/>
          <p:cNvSpPr/>
          <p:nvPr/>
        </p:nvSpPr>
        <p:spPr>
          <a:xfrm>
            <a:off x="2597760" y="18162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57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14" name=""/>
          <p:cNvSpPr/>
          <p:nvPr/>
        </p:nvSpPr>
        <p:spPr>
          <a:xfrm>
            <a:off x="3102480" y="18162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15" name=""/>
          <p:cNvGrpSpPr/>
          <p:nvPr/>
        </p:nvGrpSpPr>
        <p:grpSpPr>
          <a:xfrm>
            <a:off x="2515680" y="1968480"/>
            <a:ext cx="1086480" cy="1304640"/>
            <a:chOff x="2515680" y="1968480"/>
            <a:chExt cx="1086480" cy="1304640"/>
          </a:xfrm>
        </p:grpSpPr>
        <p:pic>
          <p:nvPicPr>
            <p:cNvPr id="416" name="" descr=""/>
            <p:cNvPicPr/>
            <p:nvPr/>
          </p:nvPicPr>
          <p:blipFill>
            <a:blip r:embed="rId2"/>
            <a:stretch/>
          </p:blipFill>
          <p:spPr>
            <a:xfrm>
              <a:off x="2521080" y="1968480"/>
              <a:ext cx="1079280" cy="1079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17" name=""/>
            <p:cNvSpPr/>
            <p:nvPr/>
          </p:nvSpPr>
          <p:spPr>
            <a:xfrm>
              <a:off x="2595600" y="308772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3132000" y="3087720"/>
              <a:ext cx="43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2515680" y="308772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3058560" y="308628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3084480" y="1984320"/>
              <a:ext cx="0" cy="9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22" name=""/>
          <p:cNvSpPr/>
          <p:nvPr/>
        </p:nvSpPr>
        <p:spPr>
          <a:xfrm>
            <a:off x="2644920" y="1542960"/>
            <a:ext cx="869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800" spc="-1" strike="noStrike">
                <a:solidFill>
                  <a:srgbClr val="000000"/>
                </a:solidFill>
                <a:latin typeface="Arial"/>
              </a:rPr>
              <a:t>glgBI 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luster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(SCO5440-44)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3" name=""/>
          <p:cNvSpPr/>
          <p:nvPr/>
        </p:nvSpPr>
        <p:spPr>
          <a:xfrm>
            <a:off x="4883760" y="18162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57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4" name=""/>
          <p:cNvSpPr/>
          <p:nvPr/>
        </p:nvSpPr>
        <p:spPr>
          <a:xfrm>
            <a:off x="5388480" y="18162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5" name=""/>
          <p:cNvGrpSpPr/>
          <p:nvPr/>
        </p:nvGrpSpPr>
        <p:grpSpPr>
          <a:xfrm>
            <a:off x="4801680" y="1968480"/>
            <a:ext cx="1086480" cy="1301400"/>
            <a:chOff x="4801680" y="1968480"/>
            <a:chExt cx="1086480" cy="1301400"/>
          </a:xfrm>
        </p:grpSpPr>
        <p:pic>
          <p:nvPicPr>
            <p:cNvPr id="426" name="" descr=""/>
            <p:cNvPicPr/>
            <p:nvPr/>
          </p:nvPicPr>
          <p:blipFill>
            <a:blip r:embed="rId3"/>
            <a:stretch/>
          </p:blipFill>
          <p:spPr>
            <a:xfrm>
              <a:off x="4807080" y="1968480"/>
              <a:ext cx="107964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27" name=""/>
            <p:cNvSpPr/>
            <p:nvPr/>
          </p:nvSpPr>
          <p:spPr>
            <a:xfrm>
              <a:off x="4881600" y="3084480"/>
              <a:ext cx="43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5418360" y="3084480"/>
              <a:ext cx="43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4801680" y="308448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5344560" y="3083040"/>
              <a:ext cx="543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2 – 120 h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5370480" y="1981080"/>
              <a:ext cx="0" cy="93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32" name=""/>
          <p:cNvSpPr/>
          <p:nvPr/>
        </p:nvSpPr>
        <p:spPr>
          <a:xfrm>
            <a:off x="4956480" y="1542960"/>
            <a:ext cx="840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gvp2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luster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(SCO0649-58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3" name=""/>
          <p:cNvSpPr/>
          <p:nvPr/>
        </p:nvSpPr>
        <p:spPr>
          <a:xfrm>
            <a:off x="501480" y="4147560"/>
            <a:ext cx="853956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ig. S6. The two gene clusters for glycogen biosynthesis i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S. coelicolor,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nd the gas vesicle biosynthesis cluster gvp2, are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ignificantly differently transcribed between strain M600 (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+ ppGpp+) and M570 (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 ppGpp-). In each panel, the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x-axis represents culture age, and the y-axis is normalized transcript abundance in log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scal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4" name="" descr=""/>
          <p:cNvPicPr/>
          <p:nvPr/>
        </p:nvPicPr>
        <p:blipFill>
          <a:blip r:embed="rId1"/>
          <a:stretch/>
        </p:blipFill>
        <p:spPr>
          <a:xfrm>
            <a:off x="3164040" y="3197160"/>
            <a:ext cx="1079280" cy="1079640"/>
          </a:xfrm>
          <a:prstGeom prst="rect">
            <a:avLst/>
          </a:prstGeom>
          <a:ln w="0">
            <a:noFill/>
          </a:ln>
        </p:spPr>
      </p:pic>
      <p:pic>
        <p:nvPicPr>
          <p:cNvPr id="435" name="" descr=""/>
          <p:cNvPicPr/>
          <p:nvPr/>
        </p:nvPicPr>
        <p:blipFill>
          <a:blip r:embed="rId2"/>
          <a:stretch/>
        </p:blipFill>
        <p:spPr>
          <a:xfrm>
            <a:off x="4505400" y="1282680"/>
            <a:ext cx="1079280" cy="1079640"/>
          </a:xfrm>
          <a:prstGeom prst="rect">
            <a:avLst/>
          </a:prstGeom>
          <a:ln w="0">
            <a:noFill/>
          </a:ln>
        </p:spPr>
      </p:pic>
      <p:pic>
        <p:nvPicPr>
          <p:cNvPr id="436" name="" descr=""/>
          <p:cNvPicPr/>
          <p:nvPr/>
        </p:nvPicPr>
        <p:blipFill>
          <a:blip r:embed="rId3"/>
          <a:stretch/>
        </p:blipFill>
        <p:spPr>
          <a:xfrm>
            <a:off x="3152880" y="1282680"/>
            <a:ext cx="1079280" cy="1079640"/>
          </a:xfrm>
          <a:prstGeom prst="rect">
            <a:avLst/>
          </a:prstGeom>
          <a:ln w="0">
            <a:noFill/>
          </a:ln>
        </p:spPr>
      </p:pic>
      <p:pic>
        <p:nvPicPr>
          <p:cNvPr id="437" name="" descr=""/>
          <p:cNvPicPr/>
          <p:nvPr/>
        </p:nvPicPr>
        <p:blipFill>
          <a:blip r:embed="rId4"/>
          <a:stretch/>
        </p:blipFill>
        <p:spPr>
          <a:xfrm>
            <a:off x="4505400" y="3197160"/>
            <a:ext cx="1079280" cy="1079640"/>
          </a:xfrm>
          <a:prstGeom prst="rect">
            <a:avLst/>
          </a:prstGeom>
          <a:ln w="0">
            <a:noFill/>
          </a:ln>
        </p:spPr>
      </p:pic>
      <p:sp>
        <p:nvSpPr>
          <p:cNvPr id="438" name=""/>
          <p:cNvSpPr/>
          <p:nvPr/>
        </p:nvSpPr>
        <p:spPr>
          <a:xfrm>
            <a:off x="3226320" y="112536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57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9" name=""/>
          <p:cNvSpPr/>
          <p:nvPr/>
        </p:nvSpPr>
        <p:spPr>
          <a:xfrm>
            <a:off x="3731040" y="112536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0" name=""/>
          <p:cNvSpPr/>
          <p:nvPr/>
        </p:nvSpPr>
        <p:spPr>
          <a:xfrm>
            <a:off x="3224160" y="2397240"/>
            <a:ext cx="432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1" name=""/>
          <p:cNvSpPr/>
          <p:nvPr/>
        </p:nvSpPr>
        <p:spPr>
          <a:xfrm>
            <a:off x="3760920" y="239724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2" name=""/>
          <p:cNvSpPr/>
          <p:nvPr/>
        </p:nvSpPr>
        <p:spPr>
          <a:xfrm>
            <a:off x="3144240" y="2397240"/>
            <a:ext cx="54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2 – 120 h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3" name=""/>
          <p:cNvSpPr/>
          <p:nvPr/>
        </p:nvSpPr>
        <p:spPr>
          <a:xfrm>
            <a:off x="3687120" y="2395440"/>
            <a:ext cx="54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2 – 120 h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4" name=""/>
          <p:cNvSpPr/>
          <p:nvPr/>
        </p:nvSpPr>
        <p:spPr>
          <a:xfrm>
            <a:off x="3713040" y="1293840"/>
            <a:ext cx="0" cy="934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5" name=""/>
          <p:cNvSpPr/>
          <p:nvPr/>
        </p:nvSpPr>
        <p:spPr>
          <a:xfrm>
            <a:off x="3046680" y="914400"/>
            <a:ext cx="132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CO0895 (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hrdC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6" name=""/>
          <p:cNvSpPr/>
          <p:nvPr/>
        </p:nvSpPr>
        <p:spPr>
          <a:xfrm>
            <a:off x="4582080" y="30402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57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7" name=""/>
          <p:cNvSpPr/>
          <p:nvPr/>
        </p:nvSpPr>
        <p:spPr>
          <a:xfrm>
            <a:off x="5086800" y="30402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8" name=""/>
          <p:cNvSpPr/>
          <p:nvPr/>
        </p:nvSpPr>
        <p:spPr>
          <a:xfrm>
            <a:off x="4579920" y="431172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9" name=""/>
          <p:cNvSpPr/>
          <p:nvPr/>
        </p:nvSpPr>
        <p:spPr>
          <a:xfrm>
            <a:off x="5116680" y="431172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0" name=""/>
          <p:cNvSpPr/>
          <p:nvPr/>
        </p:nvSpPr>
        <p:spPr>
          <a:xfrm>
            <a:off x="4500000" y="4311720"/>
            <a:ext cx="54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2 – 120 h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1" name=""/>
          <p:cNvSpPr/>
          <p:nvPr/>
        </p:nvSpPr>
        <p:spPr>
          <a:xfrm>
            <a:off x="5042880" y="4309920"/>
            <a:ext cx="54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2 – 120 h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2" name=""/>
          <p:cNvSpPr/>
          <p:nvPr/>
        </p:nvSpPr>
        <p:spPr>
          <a:xfrm>
            <a:off x="5068800" y="3208320"/>
            <a:ext cx="0" cy="934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3" name=""/>
          <p:cNvSpPr/>
          <p:nvPr/>
        </p:nvSpPr>
        <p:spPr>
          <a:xfrm>
            <a:off x="4582080" y="11304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57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4" name=""/>
          <p:cNvSpPr/>
          <p:nvPr/>
        </p:nvSpPr>
        <p:spPr>
          <a:xfrm>
            <a:off x="5086800" y="11304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5" name=""/>
          <p:cNvSpPr/>
          <p:nvPr/>
        </p:nvSpPr>
        <p:spPr>
          <a:xfrm>
            <a:off x="4579920" y="240192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6" name=""/>
          <p:cNvSpPr/>
          <p:nvPr/>
        </p:nvSpPr>
        <p:spPr>
          <a:xfrm>
            <a:off x="5116680" y="240192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7" name=""/>
          <p:cNvSpPr/>
          <p:nvPr/>
        </p:nvSpPr>
        <p:spPr>
          <a:xfrm>
            <a:off x="4500000" y="2401920"/>
            <a:ext cx="54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2 – 120 h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8" name=""/>
          <p:cNvSpPr/>
          <p:nvPr/>
        </p:nvSpPr>
        <p:spPr>
          <a:xfrm>
            <a:off x="5042880" y="2400480"/>
            <a:ext cx="54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2 – 120 h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9" name=""/>
          <p:cNvSpPr/>
          <p:nvPr/>
        </p:nvSpPr>
        <p:spPr>
          <a:xfrm>
            <a:off x="5068800" y="1298520"/>
            <a:ext cx="0" cy="934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0" name=""/>
          <p:cNvSpPr/>
          <p:nvPr/>
        </p:nvSpPr>
        <p:spPr>
          <a:xfrm>
            <a:off x="4399200" y="914400"/>
            <a:ext cx="132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CO3202 (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hrdD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1" name=""/>
          <p:cNvSpPr/>
          <p:nvPr/>
        </p:nvSpPr>
        <p:spPr>
          <a:xfrm>
            <a:off x="3236040" y="30402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57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2" name=""/>
          <p:cNvSpPr/>
          <p:nvPr/>
        </p:nvSpPr>
        <p:spPr>
          <a:xfrm>
            <a:off x="3740760" y="3040200"/>
            <a:ext cx="43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6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3" name=""/>
          <p:cNvSpPr/>
          <p:nvPr/>
        </p:nvSpPr>
        <p:spPr>
          <a:xfrm>
            <a:off x="3233880" y="431172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4" name=""/>
          <p:cNvSpPr/>
          <p:nvPr/>
        </p:nvSpPr>
        <p:spPr>
          <a:xfrm>
            <a:off x="3770280" y="4311720"/>
            <a:ext cx="432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5" name=""/>
          <p:cNvSpPr/>
          <p:nvPr/>
        </p:nvSpPr>
        <p:spPr>
          <a:xfrm>
            <a:off x="3153960" y="4311720"/>
            <a:ext cx="54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2 – 120 h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6" name=""/>
          <p:cNvSpPr/>
          <p:nvPr/>
        </p:nvSpPr>
        <p:spPr>
          <a:xfrm>
            <a:off x="3696840" y="4309920"/>
            <a:ext cx="54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2 – 120 h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7" name=""/>
          <p:cNvSpPr/>
          <p:nvPr/>
        </p:nvSpPr>
        <p:spPr>
          <a:xfrm>
            <a:off x="3722760" y="3208320"/>
            <a:ext cx="0" cy="934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8" name=""/>
          <p:cNvSpPr/>
          <p:nvPr/>
        </p:nvSpPr>
        <p:spPr>
          <a:xfrm>
            <a:off x="3053160" y="2773440"/>
            <a:ext cx="1301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CO5216 (sigR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9" name=""/>
          <p:cNvSpPr/>
          <p:nvPr/>
        </p:nvSpPr>
        <p:spPr>
          <a:xfrm>
            <a:off x="4370400" y="2773440"/>
            <a:ext cx="1319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CO1421 (rbpA)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0" name=""/>
          <p:cNvSpPr/>
          <p:nvPr/>
        </p:nvSpPr>
        <p:spPr>
          <a:xfrm>
            <a:off x="504720" y="5138280"/>
            <a:ext cx="8152560" cy="66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ig. S7. The RNA polymerase sigma factors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hrdC,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hrdB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sigR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, and the RNA polymerase-binding protei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bp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, are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ignificantly differently transcribed between strain M600 (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+ ppGpp+) and M570 (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relA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- ppGpp-). In each panel, the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x-axis represents culture age, and the y-axis is normalized transcript abundance in log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scal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1" name="glnoperon" descr=""/>
          <p:cNvPicPr/>
          <p:nvPr/>
        </p:nvPicPr>
        <p:blipFill>
          <a:blip r:embed="rId1"/>
          <a:stretch/>
        </p:blipFill>
        <p:spPr>
          <a:xfrm>
            <a:off x="3809880" y="2349360"/>
            <a:ext cx="1079640" cy="1079640"/>
          </a:xfrm>
          <a:prstGeom prst="rect">
            <a:avLst/>
          </a:prstGeom>
          <a:ln w="0">
            <a:noFill/>
          </a:ln>
        </p:spPr>
      </p:pic>
      <p:sp>
        <p:nvSpPr>
          <p:cNvPr id="472" name=""/>
          <p:cNvSpPr/>
          <p:nvPr/>
        </p:nvSpPr>
        <p:spPr>
          <a:xfrm>
            <a:off x="3862080" y="2022480"/>
            <a:ext cx="545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65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ppGpp+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3" name=""/>
          <p:cNvSpPr/>
          <p:nvPr/>
        </p:nvSpPr>
        <p:spPr>
          <a:xfrm>
            <a:off x="4389480" y="2022480"/>
            <a:ext cx="51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M667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ppGpp-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4" name=""/>
          <p:cNvSpPr/>
          <p:nvPr/>
        </p:nvSpPr>
        <p:spPr>
          <a:xfrm>
            <a:off x="3881520" y="3467160"/>
            <a:ext cx="4316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5" name=""/>
          <p:cNvSpPr/>
          <p:nvPr/>
        </p:nvSpPr>
        <p:spPr>
          <a:xfrm>
            <a:off x="4417920" y="3467160"/>
            <a:ext cx="432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6" name=""/>
          <p:cNvSpPr/>
          <p:nvPr/>
        </p:nvSpPr>
        <p:spPr>
          <a:xfrm>
            <a:off x="3801600" y="3467160"/>
            <a:ext cx="538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 – 90 min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7" name=""/>
          <p:cNvSpPr/>
          <p:nvPr/>
        </p:nvSpPr>
        <p:spPr>
          <a:xfrm>
            <a:off x="4344480" y="3465360"/>
            <a:ext cx="5389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 – 90 min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8" name=""/>
          <p:cNvSpPr/>
          <p:nvPr/>
        </p:nvSpPr>
        <p:spPr>
          <a:xfrm>
            <a:off x="4370400" y="2363760"/>
            <a:ext cx="0" cy="934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9" name=""/>
          <p:cNvSpPr/>
          <p:nvPr/>
        </p:nvSpPr>
        <p:spPr>
          <a:xfrm>
            <a:off x="941760" y="4177800"/>
            <a:ext cx="7536960" cy="84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Fig. S8. The glutamine synthetase II gene, and the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amtB-glnK-glnD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operon in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S. coelicolor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are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ignificantly  over-expressed in uninduced control cultures of strain M667 (ppGpp = 0 pmol/mg) compared to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653 (ppGpp = 6 pmol/mg). In each panel, the x-axis represents culture age, and the y-axis is normalized 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transcript abundance in log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scale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9T12:36:14Z</dcterms:created>
  <dc:creator>ahesketh</dc:creator>
  <dc:description/>
  <dc:language>en-US</dc:language>
  <cp:lastModifiedBy>ahesketh</cp:lastModifiedBy>
  <dcterms:modified xsi:type="dcterms:W3CDTF">2007-04-30T11:45:50Z</dcterms:modified>
  <cp:revision>10</cp:revision>
  <dc:subject/>
  <dc:title>PowerPoint Presentation</dc:title>
</cp:coreProperties>
</file>